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1" r:id="rId2"/>
    <p:sldId id="262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BDBBBD"/>
    <a:srgbClr val="B7B5B7"/>
    <a:srgbClr val="777678"/>
    <a:srgbClr val="6B727A"/>
    <a:srgbClr val="676B73"/>
    <a:srgbClr val="5E6267"/>
    <a:srgbClr val="44474A"/>
    <a:srgbClr val="535559"/>
    <a:srgbClr val="4D4D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961"/>
    <p:restoredTop sz="94558"/>
  </p:normalViewPr>
  <p:slideViewPr>
    <p:cSldViewPr snapToGrid="0" snapToObjects="1">
      <p:cViewPr>
        <p:scale>
          <a:sx n="161" d="100"/>
          <a:sy n="161" d="100"/>
        </p:scale>
        <p:origin x="43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suketakada\Desktop\Molecular_Virology_RIMD\metagenome_crane\izumi_output2\Eukaryota_genus_su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suketakada\Desktop\Molecular_Virology_RIMD\metagenome_crane\izumi_output2\Archaea_genus_sum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suketakada\Desktop\Molecular_Virology_RIMD\metagenome_crane\izumi_output3\Eukaryota_orde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um!$A$3</c:f>
              <c:strCache>
                <c:ptCount val="1"/>
                <c:pt idx="0">
                  <c:v>Tenualos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3:$L$3</c:f>
              <c:numCache>
                <c:formatCode>General</c:formatCode>
                <c:ptCount val="11"/>
                <c:pt idx="0">
                  <c:v>26.26533083128696</c:v>
                </c:pt>
                <c:pt idx="1">
                  <c:v>0.35907611068077888</c:v>
                </c:pt>
                <c:pt idx="2">
                  <c:v>32.111513773388722</c:v>
                </c:pt>
                <c:pt idx="3">
                  <c:v>24.051399869081546</c:v>
                </c:pt>
                <c:pt idx="4">
                  <c:v>12.946478765895385</c:v>
                </c:pt>
                <c:pt idx="5">
                  <c:v>3.5272233129347392</c:v>
                </c:pt>
                <c:pt idx="7">
                  <c:v>0.34838054066089419</c:v>
                </c:pt>
                <c:pt idx="8">
                  <c:v>7.3364159592056417</c:v>
                </c:pt>
                <c:pt idx="9">
                  <c:v>6.2305006735535446</c:v>
                </c:pt>
                <c:pt idx="10">
                  <c:v>17.1857526931947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C8-D444-9D8D-A96E1A71F36A}"/>
            </c:ext>
          </c:extLst>
        </c:ser>
        <c:ser>
          <c:idx val="1"/>
          <c:order val="1"/>
          <c:tx>
            <c:strRef>
              <c:f>Sum!$A$4</c:f>
              <c:strCache>
                <c:ptCount val="1"/>
                <c:pt idx="0">
                  <c:v>Plutell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4:$L$4</c:f>
              <c:numCache>
                <c:formatCode>General</c:formatCode>
                <c:ptCount val="11"/>
                <c:pt idx="0">
                  <c:v>16.450209352659162</c:v>
                </c:pt>
                <c:pt idx="1">
                  <c:v>0.25889569132824169</c:v>
                </c:pt>
                <c:pt idx="2">
                  <c:v>18.783173756758224</c:v>
                </c:pt>
                <c:pt idx="3">
                  <c:v>10.736846282333538</c:v>
                </c:pt>
                <c:pt idx="4">
                  <c:v>10.643916743190774</c:v>
                </c:pt>
                <c:pt idx="5">
                  <c:v>2.0408641427365719</c:v>
                </c:pt>
                <c:pt idx="7">
                  <c:v>0.19654593322523911</c:v>
                </c:pt>
                <c:pt idx="8">
                  <c:v>4.4581738518205123</c:v>
                </c:pt>
                <c:pt idx="9">
                  <c:v>4.5418949643504796</c:v>
                </c:pt>
                <c:pt idx="10">
                  <c:v>9.29285234633412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C8-D444-9D8D-A96E1A71F36A}"/>
            </c:ext>
          </c:extLst>
        </c:ser>
        <c:ser>
          <c:idx val="2"/>
          <c:order val="2"/>
          <c:tx>
            <c:strRef>
              <c:f>Sum!$A$5</c:f>
              <c:strCache>
                <c:ptCount val="1"/>
                <c:pt idx="0">
                  <c:v>Pterocnemi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5:$L$5</c:f>
              <c:numCache>
                <c:formatCode>General</c:formatCode>
                <c:ptCount val="11"/>
                <c:pt idx="0">
                  <c:v>10.410705327797034</c:v>
                </c:pt>
                <c:pt idx="1">
                  <c:v>0.23770758922728344</c:v>
                </c:pt>
                <c:pt idx="2">
                  <c:v>10.218301203206382</c:v>
                </c:pt>
                <c:pt idx="3">
                  <c:v>5.7092673583892921</c:v>
                </c:pt>
                <c:pt idx="4">
                  <c:v>4.5401478389283403</c:v>
                </c:pt>
                <c:pt idx="5">
                  <c:v>1.5871427698426703</c:v>
                </c:pt>
                <c:pt idx="7">
                  <c:v>0.12524249185476116</c:v>
                </c:pt>
                <c:pt idx="8">
                  <c:v>1.9653342665675946</c:v>
                </c:pt>
                <c:pt idx="9">
                  <c:v>1.6226385395721403</c:v>
                </c:pt>
                <c:pt idx="10">
                  <c:v>5.51504986604282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C8-D444-9D8D-A96E1A71F36A}"/>
            </c:ext>
          </c:extLst>
        </c:ser>
        <c:ser>
          <c:idx val="3"/>
          <c:order val="3"/>
          <c:tx>
            <c:strRef>
              <c:f>Sum!$A$6</c:f>
              <c:strCache>
                <c:ptCount val="1"/>
                <c:pt idx="0">
                  <c:v>Ceratosole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6:$L$6</c:f>
              <c:numCache>
                <c:formatCode>General</c:formatCode>
                <c:ptCount val="11"/>
                <c:pt idx="0">
                  <c:v>8.109466977558407</c:v>
                </c:pt>
                <c:pt idx="1">
                  <c:v>0.16696117015662754</c:v>
                </c:pt>
                <c:pt idx="2">
                  <c:v>10.74843324591774</c:v>
                </c:pt>
                <c:pt idx="3">
                  <c:v>7.1742024335528107</c:v>
                </c:pt>
                <c:pt idx="4">
                  <c:v>4.1704205461591135</c:v>
                </c:pt>
                <c:pt idx="5">
                  <c:v>0.82600483858009421</c:v>
                </c:pt>
                <c:pt idx="7">
                  <c:v>0.11072852693274145</c:v>
                </c:pt>
                <c:pt idx="8">
                  <c:v>1.8764062579059337</c:v>
                </c:pt>
                <c:pt idx="9">
                  <c:v>1.4091999115442726</c:v>
                </c:pt>
                <c:pt idx="10">
                  <c:v>5.231222981094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4C8-D444-9D8D-A96E1A71F36A}"/>
            </c:ext>
          </c:extLst>
        </c:ser>
        <c:ser>
          <c:idx val="4"/>
          <c:order val="4"/>
          <c:tx>
            <c:strRef>
              <c:f>Sum!$A$7</c:f>
              <c:strCache>
                <c:ptCount val="1"/>
                <c:pt idx="0">
                  <c:v>Cotesi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7:$L$7</c:f>
              <c:numCache>
                <c:formatCode>General</c:formatCode>
                <c:ptCount val="11"/>
                <c:pt idx="0">
                  <c:v>5.8483478117829826</c:v>
                </c:pt>
                <c:pt idx="1">
                  <c:v>4.1849801685396933E-2</c:v>
                </c:pt>
                <c:pt idx="2">
                  <c:v>2.5544955695650335</c:v>
                </c:pt>
                <c:pt idx="3">
                  <c:v>1.3592948499294215</c:v>
                </c:pt>
                <c:pt idx="4">
                  <c:v>1.2822618685744676</c:v>
                </c:pt>
                <c:pt idx="5">
                  <c:v>0.41456076287875177</c:v>
                </c:pt>
                <c:pt idx="7">
                  <c:v>3.6742708676026727E-2</c:v>
                </c:pt>
                <c:pt idx="8">
                  <c:v>0.67868917073905577</c:v>
                </c:pt>
                <c:pt idx="9">
                  <c:v>0.46449883764820088</c:v>
                </c:pt>
                <c:pt idx="10">
                  <c:v>1.25189590717912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C8-D444-9D8D-A96E1A71F36A}"/>
            </c:ext>
          </c:extLst>
        </c:ser>
        <c:ser>
          <c:idx val="5"/>
          <c:order val="5"/>
          <c:tx>
            <c:strRef>
              <c:f>Sum!$A$8</c:f>
              <c:strCache>
                <c:ptCount val="1"/>
                <c:pt idx="0">
                  <c:v>Gru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8:$L$8</c:f>
              <c:numCache>
                <c:formatCode>General</c:formatCode>
                <c:ptCount val="11"/>
                <c:pt idx="0">
                  <c:v>3.7208251691106096</c:v>
                </c:pt>
                <c:pt idx="1">
                  <c:v>17.865228747765812</c:v>
                </c:pt>
                <c:pt idx="2">
                  <c:v>0.41584968339267708</c:v>
                </c:pt>
                <c:pt idx="3">
                  <c:v>11.14069585373198</c:v>
                </c:pt>
                <c:pt idx="4">
                  <c:v>11.605996009229486</c:v>
                </c:pt>
                <c:pt idx="5">
                  <c:v>41.190538140280594</c:v>
                </c:pt>
                <c:pt idx="7">
                  <c:v>1.1769944194673139</c:v>
                </c:pt>
                <c:pt idx="8">
                  <c:v>0.73774406192622755</c:v>
                </c:pt>
                <c:pt idx="9">
                  <c:v>0.86002396398947545</c:v>
                </c:pt>
                <c:pt idx="10">
                  <c:v>0.153378329046098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4C8-D444-9D8D-A96E1A71F36A}"/>
            </c:ext>
          </c:extLst>
        </c:ser>
        <c:ser>
          <c:idx val="6"/>
          <c:order val="6"/>
          <c:tx>
            <c:strRef>
              <c:f>Sum!$A$9</c:f>
              <c:strCache>
                <c:ptCount val="1"/>
                <c:pt idx="0">
                  <c:v>Solanum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9:$L$9</c:f>
              <c:numCache>
                <c:formatCode>General</c:formatCode>
                <c:ptCount val="11"/>
                <c:pt idx="0">
                  <c:v>1.2427569104210774</c:v>
                </c:pt>
                <c:pt idx="1">
                  <c:v>12.347511633481968</c:v>
                </c:pt>
                <c:pt idx="2">
                  <c:v>1.3346903640357015</c:v>
                </c:pt>
                <c:pt idx="3">
                  <c:v>1.6939423223736199</c:v>
                </c:pt>
                <c:pt idx="4">
                  <c:v>1.6059261825602518</c:v>
                </c:pt>
                <c:pt idx="5">
                  <c:v>3.2336727905298597</c:v>
                </c:pt>
                <c:pt idx="7">
                  <c:v>23.397907128539401</c:v>
                </c:pt>
                <c:pt idx="8">
                  <c:v>15.810784705305943</c:v>
                </c:pt>
                <c:pt idx="9">
                  <c:v>17.484216585583752</c:v>
                </c:pt>
                <c:pt idx="10">
                  <c:v>1.3807956484045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4C8-D444-9D8D-A96E1A71F36A}"/>
            </c:ext>
          </c:extLst>
        </c:ser>
        <c:ser>
          <c:idx val="7"/>
          <c:order val="7"/>
          <c:tx>
            <c:strRef>
              <c:f>Sum!$A$10</c:f>
              <c:strCache>
                <c:ptCount val="1"/>
                <c:pt idx="0">
                  <c:v>Trichuri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0:$L$10</c:f>
              <c:numCache>
                <c:formatCode>General</c:formatCode>
                <c:ptCount val="11"/>
                <c:pt idx="0">
                  <c:v>9.5116090584465102E-2</c:v>
                </c:pt>
                <c:pt idx="1">
                  <c:v>7.9514353151314348</c:v>
                </c:pt>
                <c:pt idx="2">
                  <c:v>4.5598600088531643E-2</c:v>
                </c:pt>
                <c:pt idx="3">
                  <c:v>1.9859234273519315</c:v>
                </c:pt>
                <c:pt idx="4">
                  <c:v>1.2533870922523744</c:v>
                </c:pt>
                <c:pt idx="5">
                  <c:v>9.4803131536663852</c:v>
                </c:pt>
                <c:pt idx="7">
                  <c:v>2.7578352100073826</c:v>
                </c:pt>
                <c:pt idx="8">
                  <c:v>2.4733188912261546</c:v>
                </c:pt>
                <c:pt idx="9">
                  <c:v>1.1137662472641336</c:v>
                </c:pt>
                <c:pt idx="10">
                  <c:v>0.159742539017641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14C8-D444-9D8D-A96E1A71F36A}"/>
            </c:ext>
          </c:extLst>
        </c:ser>
        <c:ser>
          <c:idx val="8"/>
          <c:order val="8"/>
          <c:tx>
            <c:strRef>
              <c:f>Sum!$A$11</c:f>
              <c:strCache>
                <c:ptCount val="1"/>
                <c:pt idx="0">
                  <c:v>Arctocephalu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1:$L$11</c:f>
              <c:numCache>
                <c:formatCode>General</c:formatCode>
                <c:ptCount val="11"/>
                <c:pt idx="0">
                  <c:v>4.2416041303731382E-2</c:v>
                </c:pt>
                <c:pt idx="1">
                  <c:v>3.3214798872843718</c:v>
                </c:pt>
                <c:pt idx="2">
                  <c:v>1.5403408296086281E-2</c:v>
                </c:pt>
                <c:pt idx="3">
                  <c:v>0.79810880017156838</c:v>
                </c:pt>
                <c:pt idx="4">
                  <c:v>0.71307530778716133</c:v>
                </c:pt>
                <c:pt idx="5">
                  <c:v>3.761456032140071</c:v>
                </c:pt>
                <c:pt idx="7">
                  <c:v>1.4019353552756965E-2</c:v>
                </c:pt>
                <c:pt idx="8">
                  <c:v>1.8102303261859329</c:v>
                </c:pt>
                <c:pt idx="9">
                  <c:v>0.13823490910009886</c:v>
                </c:pt>
                <c:pt idx="10">
                  <c:v>7.204317098467766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4C8-D444-9D8D-A96E1A71F36A}"/>
            </c:ext>
          </c:extLst>
        </c:ser>
        <c:ser>
          <c:idx val="9"/>
          <c:order val="9"/>
          <c:tx>
            <c:strRef>
              <c:f>Sum!$A$12</c:f>
              <c:strCache>
                <c:ptCount val="1"/>
                <c:pt idx="0">
                  <c:v>Pristionchu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2:$L$12</c:f>
              <c:numCache>
                <c:formatCode>General</c:formatCode>
                <c:ptCount val="11"/>
                <c:pt idx="0">
                  <c:v>0.23545064382380879</c:v>
                </c:pt>
                <c:pt idx="1">
                  <c:v>2.5602282408693986</c:v>
                </c:pt>
                <c:pt idx="2">
                  <c:v>0.25097614541564345</c:v>
                </c:pt>
                <c:pt idx="3">
                  <c:v>0.37943766462473588</c:v>
                </c:pt>
                <c:pt idx="4">
                  <c:v>0.34987841986678875</c:v>
                </c:pt>
                <c:pt idx="5">
                  <c:v>0.78797187644518407</c:v>
                </c:pt>
                <c:pt idx="7">
                  <c:v>5.0165852382402276</c:v>
                </c:pt>
                <c:pt idx="8">
                  <c:v>2.8867771656749901</c:v>
                </c:pt>
                <c:pt idx="9">
                  <c:v>3.4127741255348161</c:v>
                </c:pt>
                <c:pt idx="10">
                  <c:v>0.30391904240917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14C8-D444-9D8D-A96E1A71F36A}"/>
            </c:ext>
          </c:extLst>
        </c:ser>
        <c:ser>
          <c:idx val="10"/>
          <c:order val="10"/>
          <c:tx>
            <c:strRef>
              <c:f>Sum!$A$13</c:f>
              <c:strCache>
                <c:ptCount val="1"/>
                <c:pt idx="0">
                  <c:v>Hordeum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3:$L$13</c:f>
              <c:numCache>
                <c:formatCode>General</c:formatCode>
                <c:ptCount val="11"/>
                <c:pt idx="0">
                  <c:v>0.27462463377533924</c:v>
                </c:pt>
                <c:pt idx="1">
                  <c:v>2.0984002537677413</c:v>
                </c:pt>
                <c:pt idx="2">
                  <c:v>0.19861044271397071</c:v>
                </c:pt>
                <c:pt idx="3">
                  <c:v>0.2927694238900459</c:v>
                </c:pt>
                <c:pt idx="4">
                  <c:v>0.27383721862601523</c:v>
                </c:pt>
                <c:pt idx="5">
                  <c:v>0.61782942635335103</c:v>
                </c:pt>
                <c:pt idx="7">
                  <c:v>4.3059255088942665</c:v>
                </c:pt>
                <c:pt idx="8">
                  <c:v>2.3168264691124327</c:v>
                </c:pt>
                <c:pt idx="9">
                  <c:v>2.6517436560033736</c:v>
                </c:pt>
                <c:pt idx="10">
                  <c:v>0.348104191426264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4C8-D444-9D8D-A96E1A71F36A}"/>
            </c:ext>
          </c:extLst>
        </c:ser>
        <c:ser>
          <c:idx val="11"/>
          <c:order val="11"/>
          <c:tx>
            <c:strRef>
              <c:f>Sum!$A$14</c:f>
              <c:strCache>
                <c:ptCount val="1"/>
                <c:pt idx="0">
                  <c:v>Acanthamoeb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4:$L$14</c:f>
              <c:numCache>
                <c:formatCode>General</c:formatCode>
                <c:ptCount val="11"/>
                <c:pt idx="0">
                  <c:v>0.18129357887917158</c:v>
                </c:pt>
                <c:pt idx="1">
                  <c:v>1.8071039084511056</c:v>
                </c:pt>
                <c:pt idx="2">
                  <c:v>0.19028236266282048</c:v>
                </c:pt>
                <c:pt idx="3">
                  <c:v>0.25908986372124254</c:v>
                </c:pt>
                <c:pt idx="4">
                  <c:v>0.24934699556109066</c:v>
                </c:pt>
                <c:pt idx="5">
                  <c:v>0.46959974303792701</c:v>
                </c:pt>
                <c:pt idx="7">
                  <c:v>3.8039105693255961</c:v>
                </c:pt>
                <c:pt idx="8">
                  <c:v>2.1949319953288144</c:v>
                </c:pt>
                <c:pt idx="9">
                  <c:v>2.5926228904692721</c:v>
                </c:pt>
                <c:pt idx="10">
                  <c:v>0.232076102657955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14C8-D444-9D8D-A96E1A71F36A}"/>
            </c:ext>
          </c:extLst>
        </c:ser>
        <c:ser>
          <c:idx val="12"/>
          <c:order val="12"/>
          <c:tx>
            <c:strRef>
              <c:f>Sum!$A$15</c:f>
              <c:strCache>
                <c:ptCount val="1"/>
                <c:pt idx="0">
                  <c:v>Synstelium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5:$L$15</c:f>
              <c:numCache>
                <c:formatCode>General</c:formatCode>
                <c:ptCount val="11"/>
                <c:pt idx="0">
                  <c:v>0.21749683287610747</c:v>
                </c:pt>
                <c:pt idx="1">
                  <c:v>1.731949217613588</c:v>
                </c:pt>
                <c:pt idx="2">
                  <c:v>2.2018991804937804</c:v>
                </c:pt>
                <c:pt idx="3">
                  <c:v>6.3217306999970884</c:v>
                </c:pt>
                <c:pt idx="4">
                  <c:v>2.4462229337530919</c:v>
                </c:pt>
                <c:pt idx="5">
                  <c:v>2.2306188996563376</c:v>
                </c:pt>
                <c:pt idx="7">
                  <c:v>6.0968286061669742E-2</c:v>
                </c:pt>
                <c:pt idx="8">
                  <c:v>0.33792699843355828</c:v>
                </c:pt>
                <c:pt idx="9">
                  <c:v>0.12883877956653547</c:v>
                </c:pt>
                <c:pt idx="10">
                  <c:v>0.342294282102456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4C8-D444-9D8D-A96E1A71F36A}"/>
            </c:ext>
          </c:extLst>
        </c:ser>
        <c:ser>
          <c:idx val="13"/>
          <c:order val="13"/>
          <c:tx>
            <c:strRef>
              <c:f>Sum!$A$16</c:f>
              <c:strCache>
                <c:ptCount val="1"/>
                <c:pt idx="0">
                  <c:v>Eleusine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6:$L$16</c:f>
              <c:numCache>
                <c:formatCode>General</c:formatCode>
                <c:ptCount val="11"/>
                <c:pt idx="0">
                  <c:v>4.6953712516971233</c:v>
                </c:pt>
                <c:pt idx="1">
                  <c:v>0.14286393802447847</c:v>
                </c:pt>
                <c:pt idx="2">
                  <c:v>1.5553383762164223</c:v>
                </c:pt>
                <c:pt idx="3">
                  <c:v>1.8073613923958773</c:v>
                </c:pt>
                <c:pt idx="4">
                  <c:v>15.328775279531381</c:v>
                </c:pt>
                <c:pt idx="5">
                  <c:v>0.19541596757439322</c:v>
                </c:pt>
                <c:pt idx="7">
                  <c:v>0.21607461545888701</c:v>
                </c:pt>
                <c:pt idx="8">
                  <c:v>4.3103338965573919</c:v>
                </c:pt>
                <c:pt idx="9">
                  <c:v>1.3643420278312506</c:v>
                </c:pt>
                <c:pt idx="10">
                  <c:v>24.022837860325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14C8-D444-9D8D-A96E1A71F36A}"/>
            </c:ext>
          </c:extLst>
        </c:ser>
        <c:ser>
          <c:idx val="14"/>
          <c:order val="14"/>
          <c:tx>
            <c:strRef>
              <c:f>Sum!$A$17</c:f>
              <c:strCache>
                <c:ptCount val="1"/>
                <c:pt idx="0">
                  <c:v>Acytostelium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7:$L$17</c:f>
              <c:numCache>
                <c:formatCode>General</c:formatCode>
                <c:ptCount val="11"/>
                <c:pt idx="0">
                  <c:v>3.9466253261954756</c:v>
                </c:pt>
                <c:pt idx="1">
                  <c:v>1.4829112997529366</c:v>
                </c:pt>
                <c:pt idx="2">
                  <c:v>1.551567648975654</c:v>
                </c:pt>
                <c:pt idx="3">
                  <c:v>1.0201529312094673</c:v>
                </c:pt>
                <c:pt idx="4">
                  <c:v>10.755988111550055</c:v>
                </c:pt>
                <c:pt idx="5">
                  <c:v>1.9072432215895823</c:v>
                </c:pt>
                <c:pt idx="7">
                  <c:v>6.3029762489095156E-2</c:v>
                </c:pt>
                <c:pt idx="8">
                  <c:v>2.7199434278841044</c:v>
                </c:pt>
                <c:pt idx="9">
                  <c:v>0.42552236621730816</c:v>
                </c:pt>
                <c:pt idx="10">
                  <c:v>0.628338713008175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14C8-D444-9D8D-A96E1A71F36A}"/>
            </c:ext>
          </c:extLst>
        </c:ser>
        <c:ser>
          <c:idx val="15"/>
          <c:order val="15"/>
          <c:tx>
            <c:strRef>
              <c:f>Sum!$A$18</c:f>
              <c:strCache>
                <c:ptCount val="1"/>
                <c:pt idx="0">
                  <c:v>Balearic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8:$L$18</c:f>
              <c:numCache>
                <c:formatCode>General</c:formatCode>
                <c:ptCount val="11"/>
                <c:pt idx="0">
                  <c:v>0.37091026950416467</c:v>
                </c:pt>
                <c:pt idx="1">
                  <c:v>1.779978947054552</c:v>
                </c:pt>
                <c:pt idx="2">
                  <c:v>3.3724674295815209E-2</c:v>
                </c:pt>
                <c:pt idx="3">
                  <c:v>1.088624090166052</c:v>
                </c:pt>
                <c:pt idx="4">
                  <c:v>1.1254131804785601</c:v>
                </c:pt>
                <c:pt idx="5">
                  <c:v>4.4866258524496967</c:v>
                </c:pt>
                <c:pt idx="7">
                  <c:v>1.6856737476385438E-2</c:v>
                </c:pt>
                <c:pt idx="8">
                  <c:v>1.6843861041432602E-2</c:v>
                </c:pt>
                <c:pt idx="9">
                  <c:v>1.7427219368971809E-2</c:v>
                </c:pt>
                <c:pt idx="10">
                  <c:v>9.309614385663302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14C8-D444-9D8D-A96E1A71F36A}"/>
            </c:ext>
          </c:extLst>
        </c:ser>
        <c:ser>
          <c:idx val="16"/>
          <c:order val="16"/>
          <c:tx>
            <c:strRef>
              <c:f>Sum!$A$19</c:f>
              <c:strCache>
                <c:ptCount val="1"/>
                <c:pt idx="0">
                  <c:v>Blattell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9:$L$19</c:f>
              <c:numCache>
                <c:formatCode>General</c:formatCode>
                <c:ptCount val="11"/>
                <c:pt idx="0">
                  <c:v>1.4301892082057262E-3</c:v>
                </c:pt>
                <c:pt idx="1">
                  <c:v>1.0510420314291378</c:v>
                </c:pt>
                <c:pt idx="2">
                  <c:v>2.3171666620483032E-3</c:v>
                </c:pt>
                <c:pt idx="3">
                  <c:v>2.5725220338819622E-3</c:v>
                </c:pt>
                <c:pt idx="4">
                  <c:v>4.1482756616254219E-3</c:v>
                </c:pt>
                <c:pt idx="5">
                  <c:v>8.2269491332777209E-2</c:v>
                </c:pt>
                <c:pt idx="7">
                  <c:v>2.1635110723967674</c:v>
                </c:pt>
                <c:pt idx="8">
                  <c:v>3.616364246055769</c:v>
                </c:pt>
                <c:pt idx="9">
                  <c:v>3.3854768747068018</c:v>
                </c:pt>
                <c:pt idx="10">
                  <c:v>4.655967577793291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4C8-D444-9D8D-A96E1A71F36A}"/>
            </c:ext>
          </c:extLst>
        </c:ser>
        <c:ser>
          <c:idx val="17"/>
          <c:order val="17"/>
          <c:tx>
            <c:strRef>
              <c:f>Sum!$A$20</c:f>
              <c:strCache>
                <c:ptCount val="1"/>
                <c:pt idx="0">
                  <c:v>Cajanus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20:$L$20</c:f>
              <c:numCache>
                <c:formatCode>General</c:formatCode>
                <c:ptCount val="11"/>
                <c:pt idx="0">
                  <c:v>1.2839210425436303</c:v>
                </c:pt>
                <c:pt idx="1">
                  <c:v>0.10360501512148826</c:v>
                </c:pt>
                <c:pt idx="2">
                  <c:v>0.30852105610360964</c:v>
                </c:pt>
                <c:pt idx="3">
                  <c:v>4.7617406858826037</c:v>
                </c:pt>
                <c:pt idx="4">
                  <c:v>0.3714874499561957</c:v>
                </c:pt>
                <c:pt idx="5">
                  <c:v>6.0500867370361998E-2</c:v>
                </c:pt>
                <c:pt idx="7">
                  <c:v>3.3496391430734448E-2</c:v>
                </c:pt>
                <c:pt idx="8">
                  <c:v>6.3714748113698996E-2</c:v>
                </c:pt>
                <c:pt idx="9">
                  <c:v>3.5263604676301061</c:v>
                </c:pt>
                <c:pt idx="10">
                  <c:v>2.61242533896812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14C8-D444-9D8D-A96E1A71F36A}"/>
            </c:ext>
          </c:extLst>
        </c:ser>
        <c:ser>
          <c:idx val="18"/>
          <c:order val="18"/>
          <c:tx>
            <c:strRef>
              <c:f>Sum!$A$21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21:$L$21</c:f>
              <c:numCache>
                <c:formatCode>General</c:formatCode>
                <c:ptCount val="11"/>
                <c:pt idx="0">
                  <c:v>16.60770171899253</c:v>
                </c:pt>
                <c:pt idx="1">
                  <c:v>44.691771201173658</c:v>
                </c:pt>
                <c:pt idx="2">
                  <c:v>17.479303341811132</c:v>
                </c:pt>
                <c:pt idx="3">
                  <c:v>19.416839529163298</c:v>
                </c:pt>
                <c:pt idx="4">
                  <c:v>20.333291780437847</c:v>
                </c:pt>
                <c:pt idx="5">
                  <c:v>23.100148710600649</c:v>
                </c:pt>
                <c:pt idx="7">
                  <c:v>56.15524550530985</c:v>
                </c:pt>
                <c:pt idx="8">
                  <c:v>44.389239700914807</c:v>
                </c:pt>
                <c:pt idx="9">
                  <c:v>48.629916960065472</c:v>
                </c:pt>
                <c:pt idx="10">
                  <c:v>31.2533054058412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14C8-D444-9D8D-A96E1A71F3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2947088"/>
        <c:axId val="1863152992"/>
      </c:barChart>
      <c:catAx>
        <c:axId val="186294708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1863152992"/>
        <c:crosses val="autoZero"/>
        <c:auto val="1"/>
        <c:lblAlgn val="ctr"/>
        <c:lblOffset val="100"/>
        <c:noMultiLvlLbl val="0"/>
      </c:catAx>
      <c:valAx>
        <c:axId val="1863152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1862947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4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5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6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7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8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9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0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1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2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3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4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5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6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7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8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80271078431372545"/>
          <c:y val="3.5277777777777776E-2"/>
          <c:w val="0.18898856209150328"/>
          <c:h val="0.928767901234567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/>
              </a:solidFill>
              <a:latin typeface="Arial Narrow" panose="020B0604020202020204" pitchFamily="34" charset="0"/>
              <a:ea typeface="+mn-ea"/>
              <a:cs typeface="Arial Narrow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 b="0" i="0">
          <a:solidFill>
            <a:schemeClr val="tx1"/>
          </a:solidFill>
          <a:latin typeface="Arial Narrow" panose="020B0604020202020204" pitchFamily="34" charset="0"/>
          <a:cs typeface="Arial Narrow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um!$A$3</c:f>
              <c:strCache>
                <c:ptCount val="1"/>
                <c:pt idx="0">
                  <c:v>Methanoculleu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3:$L$3</c:f>
              <c:numCache>
                <c:formatCode>General</c:formatCode>
                <c:ptCount val="11"/>
                <c:pt idx="0">
                  <c:v>90.447358627014225</c:v>
                </c:pt>
                <c:pt idx="1">
                  <c:v>84.17321365097294</c:v>
                </c:pt>
                <c:pt idx="2">
                  <c:v>93.170235572082234</c:v>
                </c:pt>
                <c:pt idx="3">
                  <c:v>94.616577366497935</c:v>
                </c:pt>
                <c:pt idx="4">
                  <c:v>94.652743922325854</c:v>
                </c:pt>
                <c:pt idx="5">
                  <c:v>96.562993294533044</c:v>
                </c:pt>
                <c:pt idx="7">
                  <c:v>86.924249853491347</c:v>
                </c:pt>
                <c:pt idx="8">
                  <c:v>82.011848234266424</c:v>
                </c:pt>
                <c:pt idx="9">
                  <c:v>88.427004259622976</c:v>
                </c:pt>
                <c:pt idx="10">
                  <c:v>94.9008980785818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F7-8A48-9274-5D14A339ACC3}"/>
            </c:ext>
          </c:extLst>
        </c:ser>
        <c:ser>
          <c:idx val="1"/>
          <c:order val="1"/>
          <c:tx>
            <c:strRef>
              <c:f>Sum!$A$4</c:f>
              <c:strCache>
                <c:ptCount val="1"/>
                <c:pt idx="0">
                  <c:v>Halorubru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4:$L$4</c:f>
              <c:numCache>
                <c:formatCode>General</c:formatCode>
                <c:ptCount val="11"/>
                <c:pt idx="0">
                  <c:v>1.9604564982489372</c:v>
                </c:pt>
                <c:pt idx="1">
                  <c:v>1.5027363676656399E-2</c:v>
                </c:pt>
                <c:pt idx="2">
                  <c:v>1.8441521787024133</c:v>
                </c:pt>
                <c:pt idx="3">
                  <c:v>1.3423213656700346</c:v>
                </c:pt>
                <c:pt idx="4">
                  <c:v>0.90793869179324316</c:v>
                </c:pt>
                <c:pt idx="5">
                  <c:v>0.18474664727881157</c:v>
                </c:pt>
                <c:pt idx="7">
                  <c:v>0.37807380225037096</c:v>
                </c:pt>
                <c:pt idx="8">
                  <c:v>0.73074445531630616</c:v>
                </c:pt>
                <c:pt idx="9">
                  <c:v>0.45058199747839794</c:v>
                </c:pt>
                <c:pt idx="10">
                  <c:v>1.16663875757861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4F7-8A48-9274-5D14A339ACC3}"/>
            </c:ext>
          </c:extLst>
        </c:ser>
        <c:ser>
          <c:idx val="2"/>
          <c:order val="2"/>
          <c:tx>
            <c:strRef>
              <c:f>Sum!$A$5</c:f>
              <c:strCache>
                <c:ptCount val="1"/>
                <c:pt idx="0">
                  <c:v>Methanobrevibacte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5:$L$5</c:f>
              <c:numCache>
                <c:formatCode>General</c:formatCode>
                <c:ptCount val="11"/>
                <c:pt idx="0">
                  <c:v>1.7341925282548205</c:v>
                </c:pt>
                <c:pt idx="1">
                  <c:v>1.172134366779199</c:v>
                </c:pt>
                <c:pt idx="2">
                  <c:v>2.1159339487853943</c:v>
                </c:pt>
                <c:pt idx="3">
                  <c:v>0.90497026415632453</c:v>
                </c:pt>
                <c:pt idx="4">
                  <c:v>0.52851264682890775</c:v>
                </c:pt>
                <c:pt idx="5">
                  <c:v>0.91586304528490647</c:v>
                </c:pt>
                <c:pt idx="7">
                  <c:v>1.1344834410959264</c:v>
                </c:pt>
                <c:pt idx="8">
                  <c:v>4.2559453978083086</c:v>
                </c:pt>
                <c:pt idx="9">
                  <c:v>2.8598532309818121</c:v>
                </c:pt>
                <c:pt idx="10">
                  <c:v>0.63710059811030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4F7-8A48-9274-5D14A339ACC3}"/>
            </c:ext>
          </c:extLst>
        </c:ser>
        <c:ser>
          <c:idx val="3"/>
          <c:order val="3"/>
          <c:tx>
            <c:strRef>
              <c:f>Sum!$A$6</c:f>
              <c:strCache>
                <c:ptCount val="1"/>
                <c:pt idx="0">
                  <c:v>Methanobacteriu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6:$L$6</c:f>
              <c:numCache>
                <c:formatCode>General</c:formatCode>
                <c:ptCount val="11"/>
                <c:pt idx="0">
                  <c:v>0.80808755077266081</c:v>
                </c:pt>
                <c:pt idx="1">
                  <c:v>11.43582375793552</c:v>
                </c:pt>
                <c:pt idx="2">
                  <c:v>0.59089113259676251</c:v>
                </c:pt>
                <c:pt idx="3">
                  <c:v>0.3102003182027418</c:v>
                </c:pt>
                <c:pt idx="4">
                  <c:v>0.41959200221061593</c:v>
                </c:pt>
                <c:pt idx="5">
                  <c:v>4.0162314625828609E-2</c:v>
                </c:pt>
                <c:pt idx="7">
                  <c:v>0.10960397047103006</c:v>
                </c:pt>
                <c:pt idx="8">
                  <c:v>0.41611347330056481</c:v>
                </c:pt>
                <c:pt idx="9">
                  <c:v>0.19404131832779603</c:v>
                </c:pt>
                <c:pt idx="10">
                  <c:v>0.107562438641999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4F7-8A48-9274-5D14A339ACC3}"/>
            </c:ext>
          </c:extLst>
        </c:ser>
        <c:ser>
          <c:idx val="4"/>
          <c:order val="4"/>
          <c:tx>
            <c:strRef>
              <c:f>Sum!$A$7</c:f>
              <c:strCache>
                <c:ptCount val="1"/>
                <c:pt idx="0">
                  <c:v>Halogranu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7:$L$7</c:f>
              <c:numCache>
                <c:formatCode>General</c:formatCode>
                <c:ptCount val="11"/>
                <c:pt idx="0">
                  <c:v>0.38166233940840671</c:v>
                </c:pt>
                <c:pt idx="1">
                  <c:v>0</c:v>
                </c:pt>
                <c:pt idx="2">
                  <c:v>0.11436602658619617</c:v>
                </c:pt>
                <c:pt idx="3">
                  <c:v>0.10810010712883039</c:v>
                </c:pt>
                <c:pt idx="4">
                  <c:v>0.22792652489949514</c:v>
                </c:pt>
                <c:pt idx="5">
                  <c:v>0</c:v>
                </c:pt>
                <c:pt idx="7">
                  <c:v>0.52181671434352506</c:v>
                </c:pt>
                <c:pt idx="8">
                  <c:v>0.25282843947376088</c:v>
                </c:pt>
                <c:pt idx="9">
                  <c:v>0.22788574864004851</c:v>
                </c:pt>
                <c:pt idx="10">
                  <c:v>0.135142540082262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4F7-8A48-9274-5D14A339ACC3}"/>
            </c:ext>
          </c:extLst>
        </c:ser>
        <c:ser>
          <c:idx val="5"/>
          <c:order val="5"/>
          <c:tx>
            <c:strRef>
              <c:f>Sum!$A$8</c:f>
              <c:strCache>
                <c:ptCount val="1"/>
                <c:pt idx="0">
                  <c:v>Methanococcu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8:$L$8</c:f>
              <c:numCache>
                <c:formatCode>General</c:formatCode>
                <c:ptCount val="11"/>
                <c:pt idx="0">
                  <c:v>0.14017845268505341</c:v>
                </c:pt>
                <c:pt idx="1">
                  <c:v>2.5696791887082444</c:v>
                </c:pt>
                <c:pt idx="2">
                  <c:v>0.11436602658619617</c:v>
                </c:pt>
                <c:pt idx="3">
                  <c:v>0.11275545814427829</c:v>
                </c:pt>
                <c:pt idx="4">
                  <c:v>2.0720587521610639E-2</c:v>
                </c:pt>
                <c:pt idx="5">
                  <c:v>1.906371206260973</c:v>
                </c:pt>
                <c:pt idx="7">
                  <c:v>7.1901480347340549E-2</c:v>
                </c:pt>
                <c:pt idx="8">
                  <c:v>0.1951234453122585</c:v>
                </c:pt>
                <c:pt idx="9">
                  <c:v>0.25733827021407618</c:v>
                </c:pt>
                <c:pt idx="10">
                  <c:v>0.107616699755277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4F7-8A48-9274-5D14A339ACC3}"/>
            </c:ext>
          </c:extLst>
        </c:ser>
        <c:ser>
          <c:idx val="6"/>
          <c:order val="6"/>
          <c:tx>
            <c:strRef>
              <c:f>Sum!$A$9</c:f>
              <c:strCache>
                <c:ptCount val="1"/>
                <c:pt idx="0">
                  <c:v>Methanosphaer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9:$L$9</c:f>
              <c:numCache>
                <c:formatCode>General</c:formatCode>
                <c:ptCount val="11"/>
                <c:pt idx="0">
                  <c:v>1.6491582668829816E-2</c:v>
                </c:pt>
                <c:pt idx="1">
                  <c:v>7.5136818383281997E-2</c:v>
                </c:pt>
                <c:pt idx="2">
                  <c:v>2.8591506646549043E-2</c:v>
                </c:pt>
                <c:pt idx="3">
                  <c:v>3.3840034713026379E-2</c:v>
                </c:pt>
                <c:pt idx="4">
                  <c:v>0</c:v>
                </c:pt>
                <c:pt idx="5">
                  <c:v>3.2129851700662883E-2</c:v>
                </c:pt>
                <c:pt idx="7">
                  <c:v>8.0885412353162683E-2</c:v>
                </c:pt>
                <c:pt idx="8">
                  <c:v>0.14771811291092837</c:v>
                </c:pt>
                <c:pt idx="9">
                  <c:v>0.17611166995531038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4F7-8A48-9274-5D14A339ACC3}"/>
            </c:ext>
          </c:extLst>
        </c:ser>
        <c:ser>
          <c:idx val="7"/>
          <c:order val="7"/>
          <c:tx>
            <c:strRef>
              <c:f>Sum!$A$10</c:f>
              <c:strCache>
                <c:ptCount val="1"/>
                <c:pt idx="0">
                  <c:v>Halopiger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0:$L$10</c:f>
              <c:numCache>
                <c:formatCode>General</c:formatCode>
                <c:ptCount val="11"/>
                <c:pt idx="0">
                  <c:v>0.27760830276144099</c:v>
                </c:pt>
                <c:pt idx="1">
                  <c:v>1.5027363676656399E-2</c:v>
                </c:pt>
                <c:pt idx="2">
                  <c:v>1.0936251292305008</c:v>
                </c:pt>
                <c:pt idx="3">
                  <c:v>0.21996022563467144</c:v>
                </c:pt>
                <c:pt idx="4">
                  <c:v>0.17094488978951022</c:v>
                </c:pt>
                <c:pt idx="5">
                  <c:v>1.6064925850331441E-2</c:v>
                </c:pt>
                <c:pt idx="7">
                  <c:v>0.30208471369576934</c:v>
                </c:pt>
                <c:pt idx="8">
                  <c:v>0.23483196366876224</c:v>
                </c:pt>
                <c:pt idx="9">
                  <c:v>0.19940002667560075</c:v>
                </c:pt>
                <c:pt idx="10">
                  <c:v>7.170828691197737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4F7-8A48-9274-5D14A339ACC3}"/>
            </c:ext>
          </c:extLst>
        </c:ser>
        <c:ser>
          <c:idx val="8"/>
          <c:order val="8"/>
          <c:tx>
            <c:strRef>
              <c:f>Sum!$A$11</c:f>
              <c:strCache>
                <c:ptCount val="1"/>
                <c:pt idx="0">
                  <c:v>Methanomassiliicoccu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1:$L$11</c:f>
              <c:numCache>
                <c:formatCode>General</c:formatCode>
                <c:ptCount val="11"/>
                <c:pt idx="0">
                  <c:v>1.6491582668829816E-2</c:v>
                </c:pt>
                <c:pt idx="1">
                  <c:v>1.5027363676656399E-2</c:v>
                </c:pt>
                <c:pt idx="2">
                  <c:v>0</c:v>
                </c:pt>
                <c:pt idx="3">
                  <c:v>2.2560023142017584E-2</c:v>
                </c:pt>
                <c:pt idx="4">
                  <c:v>3.1080889052638221E-2</c:v>
                </c:pt>
                <c:pt idx="5">
                  <c:v>1.6064925850331441E-2</c:v>
                </c:pt>
                <c:pt idx="7">
                  <c:v>2.0782829343522105</c:v>
                </c:pt>
                <c:pt idx="8">
                  <c:v>1.9278168509874269</c:v>
                </c:pt>
                <c:pt idx="9">
                  <c:v>0.48735960155259467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4F7-8A48-9274-5D14A339ACC3}"/>
            </c:ext>
          </c:extLst>
        </c:ser>
        <c:ser>
          <c:idx val="9"/>
          <c:order val="9"/>
          <c:tx>
            <c:strRef>
              <c:f>Sum!$A$12</c:f>
              <c:strCache>
                <c:ptCount val="1"/>
                <c:pt idx="0">
                  <c:v>Natronococcu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2:$L$12</c:f>
              <c:numCache>
                <c:formatCode>General</c:formatCode>
                <c:ptCount val="11"/>
                <c:pt idx="0">
                  <c:v>0.10240487838008279</c:v>
                </c:pt>
                <c:pt idx="1">
                  <c:v>1.5027363676656399E-2</c:v>
                </c:pt>
                <c:pt idx="2">
                  <c:v>5.2417752654837696E-2</c:v>
                </c:pt>
                <c:pt idx="3">
                  <c:v>6.3920058049042106E-2</c:v>
                </c:pt>
                <c:pt idx="4">
                  <c:v>0.12432354067010835</c:v>
                </c:pt>
                <c:pt idx="5">
                  <c:v>2.4097388775497164E-2</c:v>
                </c:pt>
                <c:pt idx="7">
                  <c:v>0.98089563984103623</c:v>
                </c:pt>
                <c:pt idx="8">
                  <c:v>0.25610166179637134</c:v>
                </c:pt>
                <c:pt idx="9">
                  <c:v>0.21226090504990533</c:v>
                </c:pt>
                <c:pt idx="10">
                  <c:v>0.380605552117845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4F7-8A48-9274-5D14A339ACC3}"/>
            </c:ext>
          </c:extLst>
        </c:ser>
        <c:ser>
          <c:idx val="10"/>
          <c:order val="10"/>
          <c:tx>
            <c:strRef>
              <c:f>Sum!$A$13</c:f>
              <c:strCache>
                <c:ptCount val="1"/>
                <c:pt idx="0">
                  <c:v>Methanosarcin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3:$L$13</c:f>
              <c:numCache>
                <c:formatCode>General</c:formatCode>
                <c:ptCount val="11"/>
                <c:pt idx="0">
                  <c:v>0.3778441092394233</c:v>
                </c:pt>
                <c:pt idx="1">
                  <c:v>7.0595534052832754E-2</c:v>
                </c:pt>
                <c:pt idx="2">
                  <c:v>0.12153260209318026</c:v>
                </c:pt>
                <c:pt idx="3">
                  <c:v>0.37029418504688605</c:v>
                </c:pt>
                <c:pt idx="4">
                  <c:v>8.2528152274798677E-2</c:v>
                </c:pt>
                <c:pt idx="5">
                  <c:v>3.8876365506287126E-2</c:v>
                </c:pt>
                <c:pt idx="7">
                  <c:v>0.22153318917560305</c:v>
                </c:pt>
                <c:pt idx="8">
                  <c:v>0.46465746071713832</c:v>
                </c:pt>
                <c:pt idx="9">
                  <c:v>5.5053589132419048E-2</c:v>
                </c:pt>
                <c:pt idx="10">
                  <c:v>0.9406931982556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4F7-8A48-9274-5D14A339ACC3}"/>
            </c:ext>
          </c:extLst>
        </c:ser>
        <c:ser>
          <c:idx val="11"/>
          <c:order val="11"/>
          <c:tx>
            <c:strRef>
              <c:f>Sum!$A$14</c:f>
              <c:strCache>
                <c:ptCount val="1"/>
                <c:pt idx="0">
                  <c:v>Methanoregul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4:$L$14</c:f>
              <c:numCache>
                <c:formatCode>General</c:formatCode>
                <c:ptCount val="11"/>
                <c:pt idx="0">
                  <c:v>0.26386532270127705</c:v>
                </c:pt>
                <c:pt idx="1">
                  <c:v>3.0054727353312799E-2</c:v>
                </c:pt>
                <c:pt idx="2">
                  <c:v>2.8591506646549043E-2</c:v>
                </c:pt>
                <c:pt idx="3">
                  <c:v>7.8960080997061546E-2</c:v>
                </c:pt>
                <c:pt idx="4">
                  <c:v>0.49729422484221153</c:v>
                </c:pt>
                <c:pt idx="5">
                  <c:v>5.6227240476160047E-2</c:v>
                </c:pt>
                <c:pt idx="7">
                  <c:v>0.2245983001455534</c:v>
                </c:pt>
                <c:pt idx="8">
                  <c:v>0.67420917193002905</c:v>
                </c:pt>
                <c:pt idx="9">
                  <c:v>0.15568431716263442</c:v>
                </c:pt>
                <c:pt idx="10">
                  <c:v>4.964420245015375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4F7-8A48-9274-5D14A339ACC3}"/>
            </c:ext>
          </c:extLst>
        </c:ser>
        <c:ser>
          <c:idx val="12"/>
          <c:order val="12"/>
          <c:tx>
            <c:strRef>
              <c:f>Sum!$A$15</c:f>
              <c:strCache>
                <c:ptCount val="1"/>
                <c:pt idx="0">
                  <c:v>Methanothermu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5:$L$15</c:f>
              <c:numCache>
                <c:formatCode>General</c:formatCode>
                <c:ptCount val="11"/>
                <c:pt idx="0">
                  <c:v>0</c:v>
                </c:pt>
                <c:pt idx="1">
                  <c:v>3.0054727353312799E-2</c:v>
                </c:pt>
                <c:pt idx="2">
                  <c:v>4.2887259969823566E-2</c:v>
                </c:pt>
                <c:pt idx="3">
                  <c:v>1.1280011571008792E-2</c:v>
                </c:pt>
                <c:pt idx="4">
                  <c:v>0</c:v>
                </c:pt>
                <c:pt idx="5">
                  <c:v>0.12851940680265153</c:v>
                </c:pt>
                <c:pt idx="7">
                  <c:v>8.9839320058221362E-3</c:v>
                </c:pt>
                <c:pt idx="8">
                  <c:v>3.160355493422011E-2</c:v>
                </c:pt>
                <c:pt idx="9">
                  <c:v>1.3537766709794296E-2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4F7-8A48-9274-5D14A339ACC3}"/>
            </c:ext>
          </c:extLst>
        </c:ser>
        <c:ser>
          <c:idx val="13"/>
          <c:order val="13"/>
          <c:tx>
            <c:strRef>
              <c:f>Sum!$A$16</c:f>
              <c:strCache>
                <c:ptCount val="1"/>
                <c:pt idx="0">
                  <c:v>Methanofollis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6:$L$16</c:f>
              <c:numCache>
                <c:formatCode>General</c:formatCode>
                <c:ptCount val="11"/>
                <c:pt idx="0">
                  <c:v>6.5966330675319262E-2</c:v>
                </c:pt>
                <c:pt idx="1">
                  <c:v>1.5027363676656399E-2</c:v>
                </c:pt>
                <c:pt idx="2">
                  <c:v>2.8591506646549043E-2</c:v>
                </c:pt>
                <c:pt idx="3">
                  <c:v>6.0160057952043031E-2</c:v>
                </c:pt>
                <c:pt idx="4">
                  <c:v>2.3310666789478667E-2</c:v>
                </c:pt>
                <c:pt idx="5">
                  <c:v>0</c:v>
                </c:pt>
                <c:pt idx="7">
                  <c:v>0.50901817785623482</c:v>
                </c:pt>
                <c:pt idx="8">
                  <c:v>0.4018166360503857</c:v>
                </c:pt>
                <c:pt idx="9">
                  <c:v>0.52210652708255556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4F7-8A48-9274-5D14A339ACC3}"/>
            </c:ext>
          </c:extLst>
        </c:ser>
        <c:ser>
          <c:idx val="14"/>
          <c:order val="14"/>
          <c:tx>
            <c:strRef>
              <c:f>Sum!$A$17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um!$B$2:$L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Sum!$B$17:$L$17</c:f>
              <c:numCache>
                <c:formatCode>General</c:formatCode>
                <c:ptCount val="11"/>
                <c:pt idx="0">
                  <c:v>3.4073918945206998</c:v>
                </c:pt>
                <c:pt idx="1">
                  <c:v>0.36817041007807916</c:v>
                </c:pt>
                <c:pt idx="2">
                  <c:v>0.65381785077281052</c:v>
                </c:pt>
                <c:pt idx="3">
                  <c:v>1.7441004430941121</c:v>
                </c:pt>
                <c:pt idx="4">
                  <c:v>2.3130832610015233</c:v>
                </c:pt>
                <c:pt idx="5">
                  <c:v>7.7883387054512809E-2</c:v>
                </c:pt>
                <c:pt idx="7">
                  <c:v>6.4535884385750677</c:v>
                </c:pt>
                <c:pt idx="8">
                  <c:v>7.9986411415271164</c:v>
                </c:pt>
                <c:pt idx="9">
                  <c:v>5.7617807714140952</c:v>
                </c:pt>
                <c:pt idx="10">
                  <c:v>1.50238964751413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54F7-8A48-9274-5D14A339AC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13174512"/>
        <c:axId val="1865539328"/>
      </c:barChart>
      <c:catAx>
        <c:axId val="1813174512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1865539328"/>
        <c:crosses val="autoZero"/>
        <c:auto val="1"/>
        <c:lblAlgn val="ctr"/>
        <c:lblOffset val="100"/>
        <c:noMultiLvlLbl val="0"/>
      </c:catAx>
      <c:valAx>
        <c:axId val="1865539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18131745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4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5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6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7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8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9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0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1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2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3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4"/>
        <c:txPr>
          <a:bodyPr rot="0" spcFirstLastPara="1" vertOverflow="ellipsis" vert="horz" wrap="square" anchor="ctr" anchorCtr="1"/>
          <a:lstStyle/>
          <a:p>
            <a:pPr>
              <a:defRPr lang="ja-JP" sz="1100" b="0" i="1" u="none" strike="noStrike" kern="1200" baseline="0">
                <a:solidFill>
                  <a:schemeClr val="tx1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71739133986928105"/>
          <c:y val="4.5300617283950614E-2"/>
          <c:w val="0.27015767973856208"/>
          <c:h val="0.8819604938271604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0" i="0" u="none" strike="noStrike" kern="1200" baseline="0">
              <a:solidFill>
                <a:schemeClr val="tx1"/>
              </a:solidFill>
              <a:latin typeface="Arial Narrow" panose="020B0604020202020204" pitchFamily="34" charset="0"/>
              <a:ea typeface="+mn-ea"/>
              <a:cs typeface="Arial Narrow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 b="0" i="0">
          <a:solidFill>
            <a:schemeClr val="tx1"/>
          </a:solidFill>
          <a:latin typeface="Arial Narrow" panose="020B0604020202020204" pitchFamily="34" charset="0"/>
          <a:cs typeface="Arial Narrow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Fig #2'!$A$3</c:f>
              <c:strCache>
                <c:ptCount val="1"/>
                <c:pt idx="0">
                  <c:v>Poales</c:v>
                </c:pt>
              </c:strCache>
            </c:strRef>
          </c:tx>
          <c:spPr>
            <a:solidFill>
              <a:srgbClr val="1D2D13"/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3:$M$3</c:f>
              <c:numCache>
                <c:formatCode>General</c:formatCode>
                <c:ptCount val="11"/>
                <c:pt idx="0">
                  <c:v>5.3506924339999999</c:v>
                </c:pt>
                <c:pt idx="1">
                  <c:v>3.3867026679999999</c:v>
                </c:pt>
                <c:pt idx="2">
                  <c:v>1.928138745</c:v>
                </c:pt>
                <c:pt idx="3">
                  <c:v>2.5633963849999999</c:v>
                </c:pt>
                <c:pt idx="4">
                  <c:v>16.415157959999998</c:v>
                </c:pt>
                <c:pt idx="5">
                  <c:v>1.30366994</c:v>
                </c:pt>
                <c:pt idx="7">
                  <c:v>6.153453807</c:v>
                </c:pt>
                <c:pt idx="8">
                  <c:v>7.8877350110000002</c:v>
                </c:pt>
                <c:pt idx="9">
                  <c:v>5.4040057399999997</c:v>
                </c:pt>
                <c:pt idx="10">
                  <c:v>31.56227601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56-3D47-9048-1C62308F311A}"/>
            </c:ext>
          </c:extLst>
        </c:ser>
        <c:ser>
          <c:idx val="1"/>
          <c:order val="1"/>
          <c:tx>
            <c:strRef>
              <c:f>'Fig #2'!$A$4</c:f>
              <c:strCache>
                <c:ptCount val="1"/>
                <c:pt idx="0">
                  <c:v>Fabales</c:v>
                </c:pt>
              </c:strCache>
            </c:strRef>
          </c:tx>
          <c:spPr>
            <a:solidFill>
              <a:srgbClr val="2C451D"/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4:$M$4</c:f>
              <c:numCache>
                <c:formatCode>General</c:formatCode>
                <c:ptCount val="11"/>
                <c:pt idx="0">
                  <c:v>1.3848777409999999</c:v>
                </c:pt>
                <c:pt idx="1">
                  <c:v>1.0486602840000001</c:v>
                </c:pt>
                <c:pt idx="2">
                  <c:v>0.42102614500000002</c:v>
                </c:pt>
                <c:pt idx="3">
                  <c:v>5.2447203929999997</c:v>
                </c:pt>
                <c:pt idx="4">
                  <c:v>0.52646642899999996</c:v>
                </c:pt>
                <c:pt idx="5">
                  <c:v>0.29984629000000002</c:v>
                </c:pt>
                <c:pt idx="7">
                  <c:v>1.855970326</c:v>
                </c:pt>
                <c:pt idx="8">
                  <c:v>1.1189109509999999</c:v>
                </c:pt>
                <c:pt idx="9">
                  <c:v>4.8633311240000001</c:v>
                </c:pt>
                <c:pt idx="10">
                  <c:v>2.836179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56-3D47-9048-1C62308F311A}"/>
            </c:ext>
          </c:extLst>
        </c:ser>
        <c:ser>
          <c:idx val="2"/>
          <c:order val="2"/>
          <c:tx>
            <c:strRef>
              <c:f>'Fig #2'!$A$5</c:f>
              <c:strCache>
                <c:ptCount val="1"/>
                <c:pt idx="0">
                  <c:v>Solanales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5:$M$5</c:f>
              <c:numCache>
                <c:formatCode>General</c:formatCode>
                <c:ptCount val="11"/>
                <c:pt idx="0">
                  <c:v>1.2585186420000001</c:v>
                </c:pt>
                <c:pt idx="1">
                  <c:v>13.133210399999999</c:v>
                </c:pt>
                <c:pt idx="2">
                  <c:v>1.374938862</c:v>
                </c:pt>
                <c:pt idx="3">
                  <c:v>1.831005242</c:v>
                </c:pt>
                <c:pt idx="4">
                  <c:v>1.6678202559999999</c:v>
                </c:pt>
                <c:pt idx="5">
                  <c:v>3.365348381</c:v>
                </c:pt>
                <c:pt idx="7">
                  <c:v>24.483119370000001</c:v>
                </c:pt>
                <c:pt idx="8">
                  <c:v>16.44033559</c:v>
                </c:pt>
                <c:pt idx="9">
                  <c:v>18.043129059999998</c:v>
                </c:pt>
                <c:pt idx="10">
                  <c:v>1.428571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56-3D47-9048-1C62308F311A}"/>
            </c:ext>
          </c:extLst>
        </c:ser>
        <c:ser>
          <c:idx val="3"/>
          <c:order val="3"/>
          <c:tx>
            <c:strRef>
              <c:f>'Fig #2'!$A$6</c:f>
              <c:strCache>
                <c:ptCount val="1"/>
                <c:pt idx="0">
                  <c:v>Malvales</c:v>
                </c:pt>
              </c:strCache>
            </c:strRef>
          </c:tx>
          <c:spPr>
            <a:solidFill>
              <a:srgbClr val="49722F"/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6:$M$6</c:f>
              <c:numCache>
                <c:formatCode>General</c:formatCode>
                <c:ptCount val="11"/>
                <c:pt idx="0">
                  <c:v>1.1898602279999999</c:v>
                </c:pt>
                <c:pt idx="1">
                  <c:v>3.4294093999999997E-2</c:v>
                </c:pt>
                <c:pt idx="2">
                  <c:v>1.264984932</c:v>
                </c:pt>
                <c:pt idx="3">
                  <c:v>0.99615692099999997</c:v>
                </c:pt>
                <c:pt idx="4">
                  <c:v>0.84873884899999996</c:v>
                </c:pt>
                <c:pt idx="5">
                  <c:v>0.143916716</c:v>
                </c:pt>
                <c:pt idx="7">
                  <c:v>3.6459895999999999E-2</c:v>
                </c:pt>
                <c:pt idx="8">
                  <c:v>0.31358787799999999</c:v>
                </c:pt>
                <c:pt idx="9">
                  <c:v>0.29163546600000001</c:v>
                </c:pt>
                <c:pt idx="10">
                  <c:v>0.7148416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356-3D47-9048-1C62308F311A}"/>
            </c:ext>
          </c:extLst>
        </c:ser>
        <c:ser>
          <c:idx val="4"/>
          <c:order val="4"/>
          <c:tx>
            <c:strRef>
              <c:f>'Fig #2'!$A$7</c:f>
              <c:strCache>
                <c:ptCount val="1"/>
                <c:pt idx="0">
                  <c:v>Fagal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7:$M$7</c:f>
              <c:numCache>
                <c:formatCode>General</c:formatCode>
                <c:ptCount val="11"/>
                <c:pt idx="0">
                  <c:v>5.9362539999999998E-2</c:v>
                </c:pt>
                <c:pt idx="1">
                  <c:v>1.578747229</c:v>
                </c:pt>
                <c:pt idx="2">
                  <c:v>3.1903345E-2</c:v>
                </c:pt>
                <c:pt idx="3">
                  <c:v>0.50997710299999999</c:v>
                </c:pt>
                <c:pt idx="4">
                  <c:v>0.15924834900000001</c:v>
                </c:pt>
                <c:pt idx="5">
                  <c:v>1.6113721059999999</c:v>
                </c:pt>
                <c:pt idx="7">
                  <c:v>4.1169458999999999E-2</c:v>
                </c:pt>
                <c:pt idx="8">
                  <c:v>0.184025788</c:v>
                </c:pt>
                <c:pt idx="9">
                  <c:v>7.3316754999999997E-2</c:v>
                </c:pt>
                <c:pt idx="10">
                  <c:v>0.133256174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356-3D47-9048-1C62308F311A}"/>
            </c:ext>
          </c:extLst>
        </c:ser>
        <c:ser>
          <c:idx val="5"/>
          <c:order val="5"/>
          <c:tx>
            <c:strRef>
              <c:f>'Fig #2'!$A$8</c:f>
              <c:strCache>
                <c:ptCount val="1"/>
                <c:pt idx="0">
                  <c:v>Rosales</c:v>
                </c:pt>
              </c:strCache>
            </c:strRef>
          </c:tx>
          <c:spPr>
            <a:solidFill>
              <a:srgbClr val="61983F"/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8:$M$8</c:f>
              <c:numCache>
                <c:formatCode>General</c:formatCode>
                <c:ptCount val="11"/>
                <c:pt idx="0">
                  <c:v>0.18618654500000001</c:v>
                </c:pt>
                <c:pt idx="1">
                  <c:v>0.73298613300000004</c:v>
                </c:pt>
                <c:pt idx="2">
                  <c:v>0.314285019</c:v>
                </c:pt>
                <c:pt idx="3">
                  <c:v>0.281260226</c:v>
                </c:pt>
                <c:pt idx="4">
                  <c:v>0.36016152200000001</c:v>
                </c:pt>
                <c:pt idx="5">
                  <c:v>0.27324364800000001</c:v>
                </c:pt>
                <c:pt idx="7">
                  <c:v>1.3836980729999999</c:v>
                </c:pt>
                <c:pt idx="8">
                  <c:v>0.93072023400000004</c:v>
                </c:pt>
                <c:pt idx="9">
                  <c:v>1.048343867</c:v>
                </c:pt>
                <c:pt idx="10">
                  <c:v>0.451094798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356-3D47-9048-1C62308F311A}"/>
            </c:ext>
          </c:extLst>
        </c:ser>
        <c:ser>
          <c:idx val="6"/>
          <c:order val="6"/>
          <c:tx>
            <c:strRef>
              <c:f>'Fig #2'!$A$9</c:f>
              <c:strCache>
                <c:ptCount val="1"/>
                <c:pt idx="0">
                  <c:v>Lamiale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9:$M$9</c:f>
              <c:numCache>
                <c:formatCode>General</c:formatCode>
                <c:ptCount val="11"/>
                <c:pt idx="0">
                  <c:v>7.8843581999999995E-2</c:v>
                </c:pt>
                <c:pt idx="1">
                  <c:v>0.54803651200000003</c:v>
                </c:pt>
                <c:pt idx="2">
                  <c:v>6.1002168000000002E-2</c:v>
                </c:pt>
                <c:pt idx="3">
                  <c:v>9.9815713E-2</c:v>
                </c:pt>
                <c:pt idx="4">
                  <c:v>0.12388490100000001</c:v>
                </c:pt>
                <c:pt idx="5">
                  <c:v>0.14637726300000001</c:v>
                </c:pt>
                <c:pt idx="7">
                  <c:v>1.0513277350000001</c:v>
                </c:pt>
                <c:pt idx="8">
                  <c:v>0.66356488499999999</c:v>
                </c:pt>
                <c:pt idx="9">
                  <c:v>0.74651317299999997</c:v>
                </c:pt>
                <c:pt idx="10">
                  <c:v>0.161947243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356-3D47-9048-1C62308F311A}"/>
            </c:ext>
          </c:extLst>
        </c:ser>
        <c:ser>
          <c:idx val="7"/>
          <c:order val="7"/>
          <c:tx>
            <c:strRef>
              <c:f>'Fig #2'!$A$10</c:f>
              <c:strCache>
                <c:ptCount val="1"/>
                <c:pt idx="0">
                  <c:v>Charales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0:$M$10</c:f>
              <c:numCache>
                <c:formatCode>General</c:formatCode>
                <c:ptCount val="11"/>
                <c:pt idx="0">
                  <c:v>2.3779869999999998E-3</c:v>
                </c:pt>
                <c:pt idx="1">
                  <c:v>0.1082424</c:v>
                </c:pt>
                <c:pt idx="2">
                  <c:v>1.286085E-3</c:v>
                </c:pt>
                <c:pt idx="3">
                  <c:v>1.5672617999999999E-2</c:v>
                </c:pt>
                <c:pt idx="4">
                  <c:v>1.2257527000000001E-2</c:v>
                </c:pt>
                <c:pt idx="5">
                  <c:v>7.2815145999999997E-2</c:v>
                </c:pt>
                <c:pt idx="7">
                  <c:v>1.0374575E-2</c:v>
                </c:pt>
                <c:pt idx="8">
                  <c:v>3.5498283999999998E-2</c:v>
                </c:pt>
                <c:pt idx="9">
                  <c:v>1.4115345260000001</c:v>
                </c:pt>
                <c:pt idx="10">
                  <c:v>2.436699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356-3D47-9048-1C62308F311A}"/>
            </c:ext>
          </c:extLst>
        </c:ser>
        <c:ser>
          <c:idx val="8"/>
          <c:order val="8"/>
          <c:tx>
            <c:strRef>
              <c:f>'Fig #2'!$A$11</c:f>
              <c:strCache>
                <c:ptCount val="1"/>
                <c:pt idx="0">
                  <c:v>Clupeiformes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1:$M$11</c:f>
              <c:numCache>
                <c:formatCode>General</c:formatCode>
                <c:ptCount val="11"/>
                <c:pt idx="0">
                  <c:v>26.466039290000001</c:v>
                </c:pt>
                <c:pt idx="1">
                  <c:v>0.413361808</c:v>
                </c:pt>
                <c:pt idx="2">
                  <c:v>32.953937070000002</c:v>
                </c:pt>
                <c:pt idx="3">
                  <c:v>25.764067839999999</c:v>
                </c:pt>
                <c:pt idx="4">
                  <c:v>13.33728428</c:v>
                </c:pt>
                <c:pt idx="5">
                  <c:v>3.634066196</c:v>
                </c:pt>
                <c:pt idx="7">
                  <c:v>0.38107056900000003</c:v>
                </c:pt>
                <c:pt idx="8">
                  <c:v>7.6388008640000002</c:v>
                </c:pt>
                <c:pt idx="9">
                  <c:v>6.4470180949999998</c:v>
                </c:pt>
                <c:pt idx="10">
                  <c:v>17.34457383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356-3D47-9048-1C62308F311A}"/>
            </c:ext>
          </c:extLst>
        </c:ser>
        <c:ser>
          <c:idx val="9"/>
          <c:order val="9"/>
          <c:tx>
            <c:strRef>
              <c:f>'Fig #2'!$A$12</c:f>
              <c:strCache>
                <c:ptCount val="1"/>
                <c:pt idx="0">
                  <c:v>Gadiformes</c:v>
                </c:pt>
              </c:strCache>
            </c:strRef>
          </c:tx>
          <c:spPr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2:$M$12</c:f>
              <c:numCache>
                <c:formatCode>General</c:formatCode>
                <c:ptCount val="11"/>
                <c:pt idx="0">
                  <c:v>2.0218723000000001E-2</c:v>
                </c:pt>
                <c:pt idx="1">
                  <c:v>2.2381760270000002</c:v>
                </c:pt>
                <c:pt idx="2">
                  <c:v>7.4340936999999996E-2</c:v>
                </c:pt>
                <c:pt idx="3">
                  <c:v>2.1375919E-2</c:v>
                </c:pt>
                <c:pt idx="4">
                  <c:v>9.6585814000000006E-2</c:v>
                </c:pt>
                <c:pt idx="5">
                  <c:v>1.6249688000000002E-2</c:v>
                </c:pt>
                <c:pt idx="7">
                  <c:v>0.15604235999999999</c:v>
                </c:pt>
                <c:pt idx="8">
                  <c:v>0.11947664600000001</c:v>
                </c:pt>
                <c:pt idx="9">
                  <c:v>0.13063851400000001</c:v>
                </c:pt>
                <c:pt idx="10">
                  <c:v>1.872172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356-3D47-9048-1C62308F311A}"/>
            </c:ext>
          </c:extLst>
        </c:ser>
        <c:ser>
          <c:idx val="10"/>
          <c:order val="10"/>
          <c:tx>
            <c:strRef>
              <c:f>'Fig #2'!$A$13</c:f>
              <c:strCache>
                <c:ptCount val="1"/>
                <c:pt idx="0">
                  <c:v>Lepidoptera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3:$M$13</c:f>
              <c:numCache>
                <c:formatCode>General</c:formatCode>
                <c:ptCount val="11"/>
                <c:pt idx="0">
                  <c:v>19.452621709999999</c:v>
                </c:pt>
                <c:pt idx="1">
                  <c:v>2.1252586789999999</c:v>
                </c:pt>
                <c:pt idx="2">
                  <c:v>22.107514649999999</c:v>
                </c:pt>
                <c:pt idx="3">
                  <c:v>13.31507088</c:v>
                </c:pt>
                <c:pt idx="4">
                  <c:v>12.94464458</c:v>
                </c:pt>
                <c:pt idx="5">
                  <c:v>3.3055890379999999</c:v>
                </c:pt>
                <c:pt idx="7">
                  <c:v>3.5634292329999999</c:v>
                </c:pt>
                <c:pt idx="8">
                  <c:v>7.3237598960000003</c:v>
                </c:pt>
                <c:pt idx="9">
                  <c:v>7.455486917</c:v>
                </c:pt>
                <c:pt idx="10">
                  <c:v>11.21213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356-3D47-9048-1C62308F311A}"/>
            </c:ext>
          </c:extLst>
        </c:ser>
        <c:ser>
          <c:idx val="11"/>
          <c:order val="11"/>
          <c:tx>
            <c:strRef>
              <c:f>'Fig #2'!$A$14</c:f>
              <c:strCache>
                <c:ptCount val="1"/>
                <c:pt idx="0">
                  <c:v>Hymenoptera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4:$M$14</c:f>
              <c:numCache>
                <c:formatCode>General</c:formatCode>
                <c:ptCount val="11"/>
                <c:pt idx="0">
                  <c:v>14.19193789</c:v>
                </c:pt>
                <c:pt idx="1">
                  <c:v>0.404460871</c:v>
                </c:pt>
                <c:pt idx="2">
                  <c:v>13.865668700000001</c:v>
                </c:pt>
                <c:pt idx="3">
                  <c:v>9.2747395949999998</c:v>
                </c:pt>
                <c:pt idx="4">
                  <c:v>5.7756450460000002</c:v>
                </c:pt>
                <c:pt idx="5">
                  <c:v>1.3203168919999999</c:v>
                </c:pt>
                <c:pt idx="7">
                  <c:v>0.21153601399999999</c:v>
                </c:pt>
                <c:pt idx="8">
                  <c:v>2.82129663</c:v>
                </c:pt>
                <c:pt idx="9">
                  <c:v>2.0234650350000001</c:v>
                </c:pt>
                <c:pt idx="10">
                  <c:v>6.754006021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356-3D47-9048-1C62308F311A}"/>
            </c:ext>
          </c:extLst>
        </c:ser>
        <c:ser>
          <c:idx val="12"/>
          <c:order val="12"/>
          <c:tx>
            <c:strRef>
              <c:f>'Fig #2'!$A$15</c:f>
              <c:strCache>
                <c:ptCount val="1"/>
                <c:pt idx="0">
                  <c:v>Blattodea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5:$M$15</c:f>
              <c:numCache>
                <c:formatCode>General</c:formatCode>
                <c:ptCount val="11"/>
                <c:pt idx="0">
                  <c:v>1.0275405E-2</c:v>
                </c:pt>
                <c:pt idx="1">
                  <c:v>1.122299529</c:v>
                </c:pt>
                <c:pt idx="2">
                  <c:v>2.3643536E-2</c:v>
                </c:pt>
                <c:pt idx="3">
                  <c:v>8.2927999999999995E-3</c:v>
                </c:pt>
                <c:pt idx="4">
                  <c:v>1.2631384000000001E-2</c:v>
                </c:pt>
                <c:pt idx="5">
                  <c:v>0.11209680399999999</c:v>
                </c:pt>
                <c:pt idx="7">
                  <c:v>2.334477487</c:v>
                </c:pt>
                <c:pt idx="8">
                  <c:v>3.898930172</c:v>
                </c:pt>
                <c:pt idx="9">
                  <c:v>3.5812121889999999</c:v>
                </c:pt>
                <c:pt idx="10">
                  <c:v>3.077008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356-3D47-9048-1C62308F311A}"/>
            </c:ext>
          </c:extLst>
        </c:ser>
        <c:ser>
          <c:idx val="13"/>
          <c:order val="13"/>
          <c:tx>
            <c:strRef>
              <c:f>'Fig #2'!$A$16</c:f>
              <c:strCache>
                <c:ptCount val="1"/>
                <c:pt idx="0">
                  <c:v>Diptera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6:$M$16</c:f>
              <c:numCache>
                <c:formatCode>General</c:formatCode>
                <c:ptCount val="11"/>
                <c:pt idx="0">
                  <c:v>0.56449524500000003</c:v>
                </c:pt>
                <c:pt idx="1">
                  <c:v>0.86012996500000005</c:v>
                </c:pt>
                <c:pt idx="2">
                  <c:v>0.70609755100000005</c:v>
                </c:pt>
                <c:pt idx="3">
                  <c:v>0.68434076099999996</c:v>
                </c:pt>
                <c:pt idx="4">
                  <c:v>0.55650659099999999</c:v>
                </c:pt>
                <c:pt idx="5">
                  <c:v>0.37639734699999999</c:v>
                </c:pt>
                <c:pt idx="7">
                  <c:v>1.6922279119999999</c:v>
                </c:pt>
                <c:pt idx="8">
                  <c:v>1.4147106570000001</c:v>
                </c:pt>
                <c:pt idx="9">
                  <c:v>1.3495260330000001</c:v>
                </c:pt>
                <c:pt idx="10">
                  <c:v>0.72684470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0356-3D47-9048-1C62308F311A}"/>
            </c:ext>
          </c:extLst>
        </c:ser>
        <c:ser>
          <c:idx val="14"/>
          <c:order val="14"/>
          <c:tx>
            <c:strRef>
              <c:f>'Fig #2'!$A$17</c:f>
              <c:strCache>
                <c:ptCount val="1"/>
                <c:pt idx="0">
                  <c:v>Isopoda</c:v>
                </c:pt>
              </c:strCache>
            </c:strRef>
          </c:tx>
          <c:spPr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7:$M$17</c:f>
              <c:numCache>
                <c:formatCode>General</c:formatCode>
                <c:ptCount val="11"/>
                <c:pt idx="0">
                  <c:v>5.2261768E-2</c:v>
                </c:pt>
                <c:pt idx="1">
                  <c:v>0.59772661100000002</c:v>
                </c:pt>
                <c:pt idx="2">
                  <c:v>5.5274271E-2</c:v>
                </c:pt>
                <c:pt idx="3">
                  <c:v>7.5029498999999999E-2</c:v>
                </c:pt>
                <c:pt idx="4">
                  <c:v>6.9189016000000006E-2</c:v>
                </c:pt>
                <c:pt idx="5">
                  <c:v>0.13614105800000001</c:v>
                </c:pt>
                <c:pt idx="7">
                  <c:v>1.061513854</c:v>
                </c:pt>
                <c:pt idx="8">
                  <c:v>0.65314588100000004</c:v>
                </c:pt>
                <c:pt idx="9">
                  <c:v>0.75956126800000001</c:v>
                </c:pt>
                <c:pt idx="10">
                  <c:v>6.2107844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0356-3D47-9048-1C62308F311A}"/>
            </c:ext>
          </c:extLst>
        </c:ser>
        <c:ser>
          <c:idx val="15"/>
          <c:order val="15"/>
          <c:tx>
            <c:strRef>
              <c:f>'Fig #2'!$A$18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 #2'!$C$2:$M$2</c:f>
              <c:strCache>
                <c:ptCount val="11"/>
                <c:pt idx="0">
                  <c:v>#1</c:v>
                </c:pt>
                <c:pt idx="1">
                  <c:v>#2</c:v>
                </c:pt>
                <c:pt idx="2">
                  <c:v>#3</c:v>
                </c:pt>
                <c:pt idx="3">
                  <c:v>#4</c:v>
                </c:pt>
                <c:pt idx="4">
                  <c:v>#5</c:v>
                </c:pt>
                <c:pt idx="5">
                  <c:v>#6</c:v>
                </c:pt>
                <c:pt idx="7">
                  <c:v>#7</c:v>
                </c:pt>
                <c:pt idx="8">
                  <c:v>#8</c:v>
                </c:pt>
                <c:pt idx="9">
                  <c:v>#9</c:v>
                </c:pt>
                <c:pt idx="10">
                  <c:v>#10</c:v>
                </c:pt>
              </c:strCache>
            </c:strRef>
          </c:cat>
          <c:val>
            <c:numRef>
              <c:f>'Fig #2'!$C$18:$M$18</c:f>
              <c:numCache>
                <c:formatCode>General</c:formatCode>
                <c:ptCount val="11"/>
                <c:pt idx="0">
                  <c:v>29.73143026999999</c:v>
                </c:pt>
                <c:pt idx="1">
                  <c:v>71.667706789999997</c:v>
                </c:pt>
                <c:pt idx="2">
                  <c:v>24.815957984000008</c:v>
                </c:pt>
                <c:pt idx="3">
                  <c:v>39.315078104999998</c:v>
                </c:pt>
                <c:pt idx="4">
                  <c:v>47.093777495999994</c:v>
                </c:pt>
                <c:pt idx="5">
                  <c:v>83.882553486999996</c:v>
                </c:pt>
                <c:pt idx="7">
                  <c:v>55.584129330000003</c:v>
                </c:pt>
                <c:pt idx="8">
                  <c:v>48.555500633000001</c:v>
                </c:pt>
                <c:pt idx="9">
                  <c:v>46.371282238000006</c:v>
                </c:pt>
                <c:pt idx="10">
                  <c:v>26.560241001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0356-3D47-9048-1C62308F31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41732991"/>
        <c:axId val="1541811471"/>
      </c:barChart>
      <c:catAx>
        <c:axId val="1541732991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1541811471"/>
        <c:crosses val="autoZero"/>
        <c:auto val="1"/>
        <c:lblAlgn val="ctr"/>
        <c:lblOffset val="100"/>
        <c:noMultiLvlLbl val="0"/>
      </c:catAx>
      <c:valAx>
        <c:axId val="154181147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  <c:crossAx val="15417329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4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5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6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7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8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9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0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1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2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3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4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egendEntry>
        <c:idx val="15"/>
        <c:txPr>
          <a:bodyPr rot="0" spcFirstLastPara="1" vertOverflow="ellipsis" vert="horz" wrap="square" anchor="ctr" anchorCtr="1"/>
          <a:lstStyle/>
          <a:p>
            <a:pPr>
              <a:defRPr lang="ja-JP" sz="1200" b="0" i="1" u="none" strike="noStrike" kern="1200" baseline="0">
                <a:solidFill>
                  <a:sysClr val="windowText" lastClr="000000"/>
                </a:solidFill>
                <a:latin typeface="Arial Narrow" panose="020B0604020202020204" pitchFamily="34" charset="0"/>
                <a:ea typeface="+mn-ea"/>
                <a:cs typeface="Arial Narrow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80055718954248367"/>
          <c:y val="4.6656726285292237E-2"/>
          <c:w val="0.18699183006535947"/>
          <c:h val="0.9184455597452209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ysClr val="windowText" lastClr="000000"/>
              </a:solidFill>
              <a:latin typeface="Arial Narrow" panose="020B0604020202020204" pitchFamily="34" charset="0"/>
              <a:ea typeface="+mn-ea"/>
              <a:cs typeface="Arial Narrow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0" i="0">
          <a:solidFill>
            <a:sysClr val="windowText" lastClr="000000"/>
          </a:solidFill>
          <a:latin typeface="Arial Narrow" panose="020B0604020202020204" pitchFamily="34" charset="0"/>
          <a:cs typeface="Arial Narrow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withinLinear" id="19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0881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313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1177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603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813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421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608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028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53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908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10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DFA66-9B5B-3649-BEBE-045AB2FEBC9E}" type="datetimeFigureOut">
              <a:rPr kumimoji="1" lang="ja-JP" altLang="en-US" smtClean="0"/>
              <a:t>2024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ACB63-391B-FC48-9726-C400B54E36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8313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E18F1024-80CD-7049-B94B-B75E5B61998E}"/>
              </a:ext>
            </a:extLst>
          </p:cNvPr>
          <p:cNvSpPr txBox="1"/>
          <p:nvPr/>
        </p:nvSpPr>
        <p:spPr>
          <a:xfrm>
            <a:off x="264694" y="3719308"/>
            <a:ext cx="1580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 Narrow" panose="020B0604020202020204" pitchFamily="34" charset="0"/>
                <a:cs typeface="Arial Narrow" panose="020B0604020202020204" pitchFamily="34" charset="0"/>
              </a:rPr>
              <a:t>B) </a:t>
            </a:r>
            <a:r>
              <a:rPr kumimoji="1" lang="en-US" altLang="ja-JP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Eukaryota</a:t>
            </a:r>
            <a:endParaRPr kumimoji="1" lang="ja-JP" altLang="en-US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5907174-9834-854E-A095-CE162BEED5B0}"/>
              </a:ext>
            </a:extLst>
          </p:cNvPr>
          <p:cNvSpPr txBox="1"/>
          <p:nvPr/>
        </p:nvSpPr>
        <p:spPr>
          <a:xfrm>
            <a:off x="1415500" y="7049538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Hooded crane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B6F15F99-75B0-1B46-9796-ABC6B0844332}"/>
              </a:ext>
            </a:extLst>
          </p:cNvPr>
          <p:cNvCxnSpPr>
            <a:cxnSpLocks/>
          </p:cNvCxnSpPr>
          <p:nvPr/>
        </p:nvCxnSpPr>
        <p:spPr>
          <a:xfrm>
            <a:off x="1101097" y="7028874"/>
            <a:ext cx="2021305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03E4447-2505-8144-8245-272AFE22AEB7}"/>
              </a:ext>
            </a:extLst>
          </p:cNvPr>
          <p:cNvSpPr txBox="1"/>
          <p:nvPr/>
        </p:nvSpPr>
        <p:spPr>
          <a:xfrm>
            <a:off x="4022017" y="7049538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Wild duck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754570E3-E526-6049-8778-63FA87BB4AD1}"/>
              </a:ext>
            </a:extLst>
          </p:cNvPr>
          <p:cNvCxnSpPr>
            <a:cxnSpLocks/>
          </p:cNvCxnSpPr>
          <p:nvPr/>
        </p:nvCxnSpPr>
        <p:spPr>
          <a:xfrm>
            <a:off x="3835232" y="7028874"/>
            <a:ext cx="1361264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2649D416-C00A-9D44-A579-78D4C6959B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0074008"/>
              </p:ext>
            </p:extLst>
          </p:nvPr>
        </p:nvGraphicFramePr>
        <p:xfrm>
          <a:off x="503662" y="4083454"/>
          <a:ext cx="5985338" cy="29661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9841FAA-6AC3-4F4D-A494-23F02CBD61FF}"/>
              </a:ext>
            </a:extLst>
          </p:cNvPr>
          <p:cNvSpPr txBox="1"/>
          <p:nvPr/>
        </p:nvSpPr>
        <p:spPr>
          <a:xfrm>
            <a:off x="4211122" y="877978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806E094-B8DD-AF47-94D9-B05F52E968FF}"/>
              </a:ext>
            </a:extLst>
          </p:cNvPr>
          <p:cNvSpPr txBox="1"/>
          <p:nvPr/>
        </p:nvSpPr>
        <p:spPr>
          <a:xfrm>
            <a:off x="264694" y="66500"/>
            <a:ext cx="1123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 Narrow" panose="020B0604020202020204" pitchFamily="34" charset="0"/>
                <a:cs typeface="Arial Narrow" panose="020B0604020202020204" pitchFamily="34" charset="0"/>
              </a:rPr>
              <a:t>A) Archaea</a:t>
            </a:r>
            <a:endParaRPr kumimoji="1" lang="ja-JP" altLang="en-US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BB6548C-C222-984E-A8CA-443362D2308F}"/>
              </a:ext>
            </a:extLst>
          </p:cNvPr>
          <p:cNvSpPr txBox="1"/>
          <p:nvPr/>
        </p:nvSpPr>
        <p:spPr>
          <a:xfrm>
            <a:off x="1389224" y="3417908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Hooded crane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4C284AB7-619A-7E46-AFA3-D2BC1A5771FF}"/>
              </a:ext>
            </a:extLst>
          </p:cNvPr>
          <p:cNvCxnSpPr>
            <a:cxnSpLocks/>
          </p:cNvCxnSpPr>
          <p:nvPr/>
        </p:nvCxnSpPr>
        <p:spPr>
          <a:xfrm>
            <a:off x="1074821" y="3397244"/>
            <a:ext cx="2021305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8676C83-8571-B643-B3FC-EBE792AA2711}"/>
              </a:ext>
            </a:extLst>
          </p:cNvPr>
          <p:cNvSpPr txBox="1"/>
          <p:nvPr/>
        </p:nvSpPr>
        <p:spPr>
          <a:xfrm>
            <a:off x="3801982" y="3432950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Wild duck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8D766177-0DA6-6440-97EB-8574E14029EE}"/>
              </a:ext>
            </a:extLst>
          </p:cNvPr>
          <p:cNvCxnSpPr>
            <a:cxnSpLocks/>
          </p:cNvCxnSpPr>
          <p:nvPr/>
        </p:nvCxnSpPr>
        <p:spPr>
          <a:xfrm>
            <a:off x="3599244" y="3397244"/>
            <a:ext cx="1361264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70EFCFA8-6622-C449-8598-53A1252750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5275201"/>
              </p:ext>
            </p:extLst>
          </p:nvPr>
        </p:nvGraphicFramePr>
        <p:xfrm>
          <a:off x="503662" y="435832"/>
          <a:ext cx="6120000" cy="29867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51CE4BF-D506-2C63-D5D2-0390A4F957F6}"/>
              </a:ext>
            </a:extLst>
          </p:cNvPr>
          <p:cNvSpPr txBox="1"/>
          <p:nvPr/>
        </p:nvSpPr>
        <p:spPr>
          <a:xfrm>
            <a:off x="264694" y="7490784"/>
            <a:ext cx="635952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Supplementary Figure 1| Proportion of the Archaeal and Eukaryotic genera in samples of hooded cranes and wild ducks.</a:t>
            </a:r>
          </a:p>
          <a:p>
            <a:pPr algn="just"/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(A) Proportion of the major archaea genera in each sample. The top 5 archaea genera in each sample are shown. The details of the results are shown in Supplementary Table 3. (B) Proportion of the major eukaryotic genera in each sample. The top 5 eukaryotic genera in each sample are shown. The details of the results are shown in Supplementary Table 5.</a:t>
            </a:r>
            <a:endParaRPr kumimoji="1" lang="ja-JP" altLang="en-US" sz="14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86A68D9-0ECC-C0F8-B7E8-01C27ED41B12}"/>
              </a:ext>
            </a:extLst>
          </p:cNvPr>
          <p:cNvSpPr txBox="1"/>
          <p:nvPr/>
        </p:nvSpPr>
        <p:spPr>
          <a:xfrm rot="16200000">
            <a:off x="-447608" y="1575325"/>
            <a:ext cx="17043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Proportion of taxon (%)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A7332E2-F10E-C6AB-7327-2527031B4A6B}"/>
              </a:ext>
            </a:extLst>
          </p:cNvPr>
          <p:cNvSpPr txBox="1"/>
          <p:nvPr/>
        </p:nvSpPr>
        <p:spPr>
          <a:xfrm rot="16200000">
            <a:off x="-433574" y="5339028"/>
            <a:ext cx="17043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Proportion of taxon (%)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735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2AF6506D-D483-2F47-9109-D7458D8FCF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12364"/>
              </p:ext>
            </p:extLst>
          </p:nvPr>
        </p:nvGraphicFramePr>
        <p:xfrm>
          <a:off x="369000" y="641684"/>
          <a:ext cx="6120000" cy="3239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3421FE3-4931-774B-86B8-CFE8A11B261A}"/>
              </a:ext>
            </a:extLst>
          </p:cNvPr>
          <p:cNvSpPr txBox="1"/>
          <p:nvPr/>
        </p:nvSpPr>
        <p:spPr>
          <a:xfrm>
            <a:off x="1400378" y="3870025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Hooded crane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A5B85023-495D-6442-8231-9ECF389A444D}"/>
              </a:ext>
            </a:extLst>
          </p:cNvPr>
          <p:cNvCxnSpPr>
            <a:cxnSpLocks/>
          </p:cNvCxnSpPr>
          <p:nvPr/>
        </p:nvCxnSpPr>
        <p:spPr>
          <a:xfrm>
            <a:off x="1085975" y="3849361"/>
            <a:ext cx="2021305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6210031-11E4-0A4D-94FD-220F00CA364D}"/>
              </a:ext>
            </a:extLst>
          </p:cNvPr>
          <p:cNvSpPr txBox="1"/>
          <p:nvPr/>
        </p:nvSpPr>
        <p:spPr>
          <a:xfrm>
            <a:off x="3896548" y="3870025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Wild duck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BA87558B-2AF0-424F-943E-A2CA1B1E74A7}"/>
              </a:ext>
            </a:extLst>
          </p:cNvPr>
          <p:cNvCxnSpPr>
            <a:cxnSpLocks/>
          </p:cNvCxnSpPr>
          <p:nvPr/>
        </p:nvCxnSpPr>
        <p:spPr>
          <a:xfrm>
            <a:off x="3701787" y="3849361"/>
            <a:ext cx="1361264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B46431A-4376-0C41-8EE4-FB7E67F5C2AE}"/>
              </a:ext>
            </a:extLst>
          </p:cNvPr>
          <p:cNvSpPr txBox="1"/>
          <p:nvPr/>
        </p:nvSpPr>
        <p:spPr>
          <a:xfrm>
            <a:off x="4095068" y="8774668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4EF1D0D-72D9-7D81-DD8B-7223AF5639C7}"/>
              </a:ext>
            </a:extLst>
          </p:cNvPr>
          <p:cNvSpPr txBox="1"/>
          <p:nvPr/>
        </p:nvSpPr>
        <p:spPr>
          <a:xfrm>
            <a:off x="369000" y="4523670"/>
            <a:ext cx="6120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Supplementary Figure 2| Proportion of major taxa of insect, fish, and plant in the eukaryotes reads identified in each sample. </a:t>
            </a:r>
          </a:p>
          <a:p>
            <a:pPr algn="just"/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Proportion of major taxa of insect, fish, and plant in the reads identified as eukaryotes in each sample are shown.</a:t>
            </a:r>
            <a:endParaRPr kumimoji="1" lang="ja-JP" altLang="en-US" sz="14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4B5598F-1413-285A-63D3-D35A4E976F8B}"/>
              </a:ext>
            </a:extLst>
          </p:cNvPr>
          <p:cNvSpPr txBox="1"/>
          <p:nvPr/>
        </p:nvSpPr>
        <p:spPr>
          <a:xfrm rot="16200000">
            <a:off x="-553920" y="1925047"/>
            <a:ext cx="17043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Proportion of taxon (%)</a:t>
            </a:r>
            <a:endParaRPr kumimoji="1" lang="ja-JP" altLang="en-US" sz="14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1094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8</TotalTime>
  <Words>175</Words>
  <Application>Microsoft Macintosh PowerPoint</Application>
  <PresentationFormat>画面に合わせる (4:3)</PresentationFormat>
  <Paragraphs>1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田 光輔</dc:creator>
  <cp:lastModifiedBy>中川 草</cp:lastModifiedBy>
  <cp:revision>61</cp:revision>
  <cp:lastPrinted>2023-02-15T02:56:42Z</cp:lastPrinted>
  <dcterms:created xsi:type="dcterms:W3CDTF">2021-02-11T08:04:08Z</dcterms:created>
  <dcterms:modified xsi:type="dcterms:W3CDTF">2024-08-04T02:01:53Z</dcterms:modified>
</cp:coreProperties>
</file>